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90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© </a:t>
            </a:r>
            <a:r>
              <a:rPr lang="en-GB" dirty="0" err="1"/>
              <a:t>Brunkwall</a:t>
            </a:r>
            <a:r>
              <a:rPr lang="en-GB" dirty="0"/>
              <a:t> and </a:t>
            </a:r>
            <a:r>
              <a:rPr lang="en-GB" dirty="0" err="1"/>
              <a:t>Orho-Melander</a:t>
            </a:r>
            <a:r>
              <a:rPr lang="en-GB" dirty="0"/>
              <a:t> 2017</a:t>
            </a:r>
          </a:p>
          <a:p>
            <a:r>
              <a:rPr lang="en-GB" dirty="0" err="1"/>
              <a:t>Diabetologia</a:t>
            </a:r>
            <a:r>
              <a:rPr lang="en-GB" dirty="0"/>
              <a:t> DOI 10.1007/s00125-017-4278-3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520" y="427861"/>
            <a:ext cx="86599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he gut</a:t>
            </a:r>
            <a:r>
              <a:rPr lang="en-GB" sz="2000" b="1" dirty="0"/>
              <a:t> microbiome as a prevention and treatment target for hyperglycaemia in type 2 diabetes: current evidence from human studies and future possibiliti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3262" y="1709175"/>
            <a:ext cx="4360423" cy="349709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12" y="1808697"/>
            <a:ext cx="1891744" cy="326983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3685" y="1808697"/>
            <a:ext cx="2624639" cy="32698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5684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3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19</cp:revision>
  <cp:lastPrinted>2017-04-13T08:27:39Z</cp:lastPrinted>
  <dcterms:created xsi:type="dcterms:W3CDTF">2016-06-15T12:53:43Z</dcterms:created>
  <dcterms:modified xsi:type="dcterms:W3CDTF">2017-04-13T09:08:48Z</dcterms:modified>
</cp:coreProperties>
</file>